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embeddings/oleObject1.bin" ContentType="application/vnd.openxmlformats-officedocument.oleObjec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373576-3CA4-4FBC-8616-69470C7D16D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EEF95D-09A7-4929-9971-7BC20974680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5F99E4-A316-4602-A5B0-2C5A977DCE1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289ECF-3019-4BED-9E31-32F721F9870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594BB0-3B6B-4188-AFF2-87A9FD80DB1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0D2AF5-E41C-41CF-9FB9-092BD0BC613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97DB66-51D2-4012-ACC2-D8334495303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CEE1A9-0EF1-466A-BADE-E63664302B7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26138B-944F-44D8-82AF-3B581EA13C7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51E2AB-E56F-4366-BDC9-4403C2851B5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5BF25F-D3D8-44C4-8DF4-3E8F6628E4E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77D12F-97ED-4D2D-B74C-B46BCCC6FB4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9CF6F18-5DEC-4A3F-B89C-7D318D59442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oleObject" Target="../embeddings/oleObject1.bin"/><Relationship Id="rId5" Type="http://schemas.openxmlformats.org/officeDocument/2006/relationships/image" Target="../media/image4.png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0" y="576360"/>
            <a:ext cx="6858000" cy="1979640"/>
          </a:xfrm>
          <a:prstGeom prst="rect">
            <a:avLst/>
          </a:prstGeom>
          <a:ln w="0">
            <a:noFill/>
          </a:ln>
        </p:spPr>
      </p:pic>
      <p:pic>
        <p:nvPicPr>
          <p:cNvPr id="43" name="" descr=""/>
          <p:cNvPicPr/>
          <p:nvPr/>
        </p:nvPicPr>
        <p:blipFill>
          <a:blip r:embed="rId2"/>
          <a:stretch/>
        </p:blipFill>
        <p:spPr>
          <a:xfrm>
            <a:off x="0" y="2847960"/>
            <a:ext cx="6858000" cy="1940040"/>
          </a:xfrm>
          <a:prstGeom prst="rect">
            <a:avLst/>
          </a:prstGeom>
          <a:ln w="0">
            <a:noFill/>
          </a:ln>
        </p:spPr>
      </p:pic>
      <p:sp>
        <p:nvSpPr>
          <p:cNvPr id="44" name=""/>
          <p:cNvSpPr/>
          <p:nvPr/>
        </p:nvSpPr>
        <p:spPr>
          <a:xfrm>
            <a:off x="5805720" y="757080"/>
            <a:ext cx="618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n=41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3789360" y="1332000"/>
            <a:ext cx="431640" cy="1008000"/>
          </a:xfrm>
          <a:prstGeom prst="ellipse">
            <a:avLst/>
          </a:prstGeom>
          <a:noFill/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6" name="" descr=""/>
          <p:cNvPicPr/>
          <p:nvPr/>
        </p:nvPicPr>
        <p:blipFill>
          <a:blip r:embed="rId3"/>
          <a:stretch/>
        </p:blipFill>
        <p:spPr>
          <a:xfrm>
            <a:off x="0" y="5148360"/>
            <a:ext cx="6858000" cy="2052720"/>
          </a:xfrm>
          <a:prstGeom prst="rect">
            <a:avLst/>
          </a:prstGeom>
          <a:ln w="0">
            <a:noFill/>
          </a:ln>
        </p:spPr>
      </p:pic>
      <p:sp>
        <p:nvSpPr>
          <p:cNvPr id="47" name=""/>
          <p:cNvSpPr/>
          <p:nvPr/>
        </p:nvSpPr>
        <p:spPr>
          <a:xfrm>
            <a:off x="5805720" y="5581800"/>
            <a:ext cx="618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n=5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8" name=""/>
          <p:cNvGraphicFramePr/>
          <p:nvPr/>
        </p:nvGraphicFramePr>
        <p:xfrm>
          <a:off x="0" y="7196040"/>
          <a:ext cx="6858000" cy="1947960"/>
        </p:xfrm>
        <a:graphic>
          <a:graphicData uri="http://schemas.openxmlformats.org/presentationml/2006/ole">
            <p:oleObj r:id="rId4" spid="">
              <p:embed/>
              <p:pic>
                <p:nvPicPr>
                  <p:cNvPr id="49" name="" descr=""/>
                  <p:cNvPicPr/>
                  <p:nvPr/>
                </p:nvPicPr>
                <p:blipFill>
                  <a:blip r:embed="rId5"/>
                  <a:stretch/>
                </p:blipFill>
                <p:spPr>
                  <a:xfrm>
                    <a:off x="0" y="7196040"/>
                    <a:ext cx="6858000" cy="19479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0" name=""/>
          <p:cNvSpPr/>
          <p:nvPr/>
        </p:nvSpPr>
        <p:spPr>
          <a:xfrm>
            <a:off x="5805360" y="7669080"/>
            <a:ext cx="703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n=133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0" y="2556000"/>
            <a:ext cx="6858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44280" y="5076720"/>
            <a:ext cx="6858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-27000" y="7380360"/>
            <a:ext cx="6858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3789360" y="3780000"/>
            <a:ext cx="431640" cy="1008000"/>
          </a:xfrm>
          <a:prstGeom prst="ellipse">
            <a:avLst/>
          </a:prstGeom>
          <a:noFill/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2924280" y="900000"/>
            <a:ext cx="431640" cy="1008000"/>
          </a:xfrm>
          <a:prstGeom prst="ellipse">
            <a:avLst/>
          </a:prstGeom>
          <a:noFill/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2997360" y="3348000"/>
            <a:ext cx="431640" cy="1008000"/>
          </a:xfrm>
          <a:prstGeom prst="ellipse">
            <a:avLst/>
          </a:prstGeom>
          <a:noFill/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2965320" y="5580000"/>
            <a:ext cx="432000" cy="1008000"/>
          </a:xfrm>
          <a:prstGeom prst="ellipse">
            <a:avLst/>
          </a:prstGeom>
          <a:noFill/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3789360" y="7885080"/>
            <a:ext cx="431640" cy="1008000"/>
          </a:xfrm>
          <a:prstGeom prst="ellipse">
            <a:avLst/>
          </a:prstGeom>
          <a:noFill/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2997360" y="7885080"/>
            <a:ext cx="431640" cy="1008000"/>
          </a:xfrm>
          <a:prstGeom prst="ellipse">
            <a:avLst/>
          </a:prstGeom>
          <a:noFill/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5805720" y="3132000"/>
            <a:ext cx="618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n=16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0" y="4680"/>
            <a:ext cx="685800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Additonal file 8, Figure S2.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GH copy number patterns in different types of tumors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howing a high frequency of gain of 7p and loss of 10q. Frequencies and plots of gains and losses were 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retreived from a CGH data base progentix www.progenetix.ne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1-18T10:16:44Z</dcterms:created>
  <dc:creator>Wikman</dc:creator>
  <dc:description/>
  <dc:language>en-US</dc:language>
  <cp:lastModifiedBy>Wikman</cp:lastModifiedBy>
  <dcterms:modified xsi:type="dcterms:W3CDTF">2012-03-15T16:35:17Z</dcterms:modified>
  <cp:revision>7</cp:revision>
  <dc:subject/>
  <dc:title>Folie 1</dc:title>
</cp:coreProperties>
</file>